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98" r:id="rId2"/>
    <p:sldId id="394" r:id="rId3"/>
    <p:sldId id="388" r:id="rId4"/>
    <p:sldId id="404" r:id="rId5"/>
    <p:sldId id="42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732" y="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D7F53A-E3D0-417C-82DE-8B3EEB5E3EB1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AB6CF2-8D94-4D8F-9EB9-27ECFB5EF5A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93295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4BD30B-6E27-4113-AC58-CCBEDF6407C2}" type="slidenum">
              <a:rPr lang="en-CA" smtClean="0"/>
              <a:t>4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793235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4BD30B-6E27-4113-AC58-CCBEDF6407C2}" type="slidenum">
              <a:rPr lang="en-CA" smtClean="0"/>
              <a:t>5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317033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6B8661-005C-4D99-B712-19B9634D61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18A81A-17A3-49DE-84A2-54A2A7E26B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9D60C9-E7F3-4873-A27C-17700D590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28804D-D072-494D-8238-DEE17C72B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133F73-5E9E-4E01-80A6-B25E40546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03102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23995C-0637-4707-A720-494AC975E6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4EFF45-6B4F-419B-811C-AC903C3FA1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749D04-C4A1-41D5-B796-919FAE691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1D2071-0F17-4F46-918C-5DD5A01A7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D7C841-1E62-4A6C-A9D0-17DCB5F082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88888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EB1004-A265-43BF-86F4-96A2774149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7A7A7F-1F83-45B6-B81D-BD47FA64AD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32BF66-069A-427A-892D-DD2FACC22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BAFE44-BA32-4D05-903E-5743E1D30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1A7234-1C87-4A8E-B1EE-B18EC67A6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5997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C3D42D-4237-411C-8B50-F286F3499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CC45DF-1653-4F50-AD06-9739F57E34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5ED4CA-A9A6-44CD-BEDC-51D990EB4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E3237A-5FE9-4D7C-932B-26790AFF1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55FC81-7F56-4124-ADBC-4834F21D1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0693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741FA-AF30-4E48-BDDB-6DA64F2315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C11D57-2BBE-4894-A743-E5881E5A1C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1AD3DC-AC5D-467E-9202-2D2ABDCF8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D8DE1F-FDE6-4468-B3DA-FB9CE32C7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99DE8B-3A08-4B7B-A986-32533D3D1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7746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3C2358-D9E1-4940-A4E6-D4CF6C169F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33365B-F8CB-441E-A96D-D75C19A105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9464B5-645A-43E7-A883-6DE478BA94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E48738-454A-42E6-BE74-F06E14391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1A61E0-4AEF-4CBB-9D35-B10198396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BF371D-6FDC-4175-8A99-2F77F91E2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4028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9E268-DDE4-4747-A338-923E89D427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868537-E986-487C-8B9B-F56C508969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F8C009-1E6D-41A5-BF53-1B3E8AB708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E693CE-E61F-44A0-BDF8-23648132D6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6ADCEA-906A-4CF5-BCA6-6A6D79A01C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127565-9497-4794-AD21-87E773D7E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68759E-6EB9-4581-92C5-B77C1477D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CEB8FC-4404-49E6-B1F3-CD943DE4B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51626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E001E-1545-47F3-83E4-BB4ADFF36E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F854FB9-19A5-4275-BB69-3C0FBA8EC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47C3B2-052C-4188-8052-4990DA53C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3CD918-B99B-43DD-A683-0F29912A7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86612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3D4CC3-6AD6-4BC7-93CA-F65FBF194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CAD601D-788C-42B5-BB27-413DFC942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6B9F04F-C719-46E9-A1C4-7040A711AF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11024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ACFA0-BB54-49F3-AAE8-AEFCDEB25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C43E68-14FD-4334-9153-770D4B4809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BE0965-0327-402B-BE43-7FE9F3B867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A5B75D-2D40-4D9A-A941-58137CCAB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ED3C3C-65A0-4EC9-890A-D5BE24FC6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3E6B46-C9AE-4FB2-8564-8CC22E8DF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70926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4010FD-9913-4B64-8F77-6D17FBCCE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990B2F7-3024-4AAD-8B30-5564941CA1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33D955-AD3A-42FC-9200-2587F546EB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4A84FA-0A87-4C81-BEA9-D4317DC70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EF3D6E-142C-4011-B820-EB4A9466B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6D60BE-8C9C-4EA3-8343-274CFEB3F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46468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D1014FD-0AC9-4C75-BF0A-DEB15A8D5C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785261-C051-42E8-BD81-8D82111870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747A86-8034-44E1-9E38-8BA0BE35EA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62255-B2E0-4295-BB4D-46EF469A646C}" type="datetimeFigureOut">
              <a:rPr lang="en-CA" smtClean="0"/>
              <a:t>2020-11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211415-E186-49A9-91CC-1A4ED4CAE6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5596F5-2F6A-48FB-A671-1F25D49E03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E671F-017C-403D-B1EC-C196A884C56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2225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57B0D-E3E7-460C-A07B-737C8BCD65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dirty="0"/>
              <a:t>Supplementary Figures 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D3607057-E25E-40ED-B724-B638E02B10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CA" dirty="0"/>
              <a:t>Revised Figures, Alotaibi et al., New figures (revised paper)</a:t>
            </a:r>
          </a:p>
        </p:txBody>
      </p:sp>
    </p:spTree>
    <p:extLst>
      <p:ext uri="{BB962C8B-B14F-4D97-AF65-F5344CB8AC3E}">
        <p14:creationId xmlns:p14="http://schemas.microsoft.com/office/powerpoint/2010/main" val="28564267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1C4FA80-4126-49BA-ACC7-F00EF5A2886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488" b="30663"/>
          <a:stretch/>
        </p:blipFill>
        <p:spPr>
          <a:xfrm>
            <a:off x="442762" y="1753645"/>
            <a:ext cx="1948787" cy="200446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73C8D0E-2D25-484C-8667-C5FD2A8D714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488" b="30663"/>
          <a:stretch/>
        </p:blipFill>
        <p:spPr>
          <a:xfrm>
            <a:off x="2499672" y="1753645"/>
            <a:ext cx="1948787" cy="200446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1059760-4F3D-42EF-8E40-A8B6F6EB8B1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793" b="32337"/>
          <a:stretch/>
        </p:blipFill>
        <p:spPr>
          <a:xfrm>
            <a:off x="4614735" y="1777837"/>
            <a:ext cx="1882930" cy="195608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314F454-C4E0-42AA-B9A1-0200F6329D6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488" b="30663"/>
          <a:stretch/>
        </p:blipFill>
        <p:spPr>
          <a:xfrm>
            <a:off x="6585917" y="1777837"/>
            <a:ext cx="1948788" cy="200446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E95DB19-43E8-424D-8DAF-F4BD26747D5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0188" b="30663"/>
          <a:stretch/>
        </p:blipFill>
        <p:spPr>
          <a:xfrm>
            <a:off x="8817414" y="1777837"/>
            <a:ext cx="1895699" cy="200446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4BD1EFD-B3EF-4270-BA8A-F49F93F72CC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488" b="30663"/>
          <a:stretch/>
        </p:blipFill>
        <p:spPr>
          <a:xfrm>
            <a:off x="8764324" y="-226629"/>
            <a:ext cx="1948789" cy="200446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4C08D75-1085-43F3-B57E-A02281001CD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9488" b="30663"/>
          <a:stretch/>
        </p:blipFill>
        <p:spPr>
          <a:xfrm>
            <a:off x="8817414" y="3782303"/>
            <a:ext cx="1948788" cy="2004466"/>
          </a:xfrm>
          <a:prstGeom prst="rect">
            <a:avLst/>
          </a:prstGeom>
        </p:spPr>
      </p:pic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75530EE0-828D-465B-B0DB-24C98CB9F1FC}"/>
              </a:ext>
            </a:extLst>
          </p:cNvPr>
          <p:cNvCxnSpPr/>
          <p:nvPr/>
        </p:nvCxnSpPr>
        <p:spPr>
          <a:xfrm>
            <a:off x="1638032" y="3272590"/>
            <a:ext cx="72637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48E6214-40AE-484B-B9C9-2A42DA2CEE0B}"/>
              </a:ext>
            </a:extLst>
          </p:cNvPr>
          <p:cNvCxnSpPr>
            <a:cxnSpLocks/>
          </p:cNvCxnSpPr>
          <p:nvPr/>
        </p:nvCxnSpPr>
        <p:spPr>
          <a:xfrm>
            <a:off x="3110875" y="3232485"/>
            <a:ext cx="1337584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817645D7-C08D-4979-854F-8FD793E5856A}"/>
              </a:ext>
            </a:extLst>
          </p:cNvPr>
          <p:cNvCxnSpPr>
            <a:cxnSpLocks/>
          </p:cNvCxnSpPr>
          <p:nvPr/>
        </p:nvCxnSpPr>
        <p:spPr>
          <a:xfrm>
            <a:off x="5888413" y="3398521"/>
            <a:ext cx="531638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CA7C120D-9EB7-4DF8-9782-E2B87165A730}"/>
              </a:ext>
            </a:extLst>
          </p:cNvPr>
          <p:cNvCxnSpPr>
            <a:cxnSpLocks/>
          </p:cNvCxnSpPr>
          <p:nvPr/>
        </p:nvCxnSpPr>
        <p:spPr>
          <a:xfrm>
            <a:off x="8336284" y="3387292"/>
            <a:ext cx="316827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40AA7BE5-5A95-4CC4-BFB2-91CDC86587BC}"/>
              </a:ext>
            </a:extLst>
          </p:cNvPr>
          <p:cNvCxnSpPr>
            <a:cxnSpLocks/>
          </p:cNvCxnSpPr>
          <p:nvPr/>
        </p:nvCxnSpPr>
        <p:spPr>
          <a:xfrm>
            <a:off x="9984608" y="3434190"/>
            <a:ext cx="0" cy="839001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06BCC4E0-1D2E-485D-A2DC-10688E48E3DC}"/>
              </a:ext>
            </a:extLst>
          </p:cNvPr>
          <p:cNvCxnSpPr>
            <a:cxnSpLocks/>
          </p:cNvCxnSpPr>
          <p:nvPr/>
        </p:nvCxnSpPr>
        <p:spPr>
          <a:xfrm flipV="1">
            <a:off x="9307762" y="1893055"/>
            <a:ext cx="0" cy="862823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itle 1">
            <a:extLst>
              <a:ext uri="{FF2B5EF4-FFF2-40B4-BE49-F238E27FC236}">
                <a16:creationId xmlns:a16="http://schemas.microsoft.com/office/drawing/2014/main" id="{D55B7562-6144-4801-84D6-201EA86443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5502" y="5553777"/>
            <a:ext cx="7838522" cy="1304223"/>
          </a:xfrm>
        </p:spPr>
        <p:txBody>
          <a:bodyPr>
            <a:normAutofit/>
          </a:bodyPr>
          <a:lstStyle/>
          <a:p>
            <a:r>
              <a:rPr lang="en-CA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E1ADD625-37BE-4DB0-8DB8-01B8D90118D4}"/>
              </a:ext>
            </a:extLst>
          </p:cNvPr>
          <p:cNvCxnSpPr>
            <a:cxnSpLocks/>
          </p:cNvCxnSpPr>
          <p:nvPr/>
        </p:nvCxnSpPr>
        <p:spPr>
          <a:xfrm>
            <a:off x="718802" y="3865722"/>
            <a:ext cx="76008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11A7AEA5-95B8-44D2-B56D-6D488CB8DB6D}"/>
              </a:ext>
            </a:extLst>
          </p:cNvPr>
          <p:cNvSpPr txBox="1"/>
          <p:nvPr/>
        </p:nvSpPr>
        <p:spPr>
          <a:xfrm>
            <a:off x="1558306" y="3696444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SC-A</a:t>
            </a:r>
            <a:endParaRPr lang="en-CA" b="1" dirty="0"/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0C4E081C-9A63-4615-8816-DC7E2ACC5685}"/>
              </a:ext>
            </a:extLst>
          </p:cNvPr>
          <p:cNvCxnSpPr>
            <a:cxnSpLocks/>
          </p:cNvCxnSpPr>
          <p:nvPr/>
        </p:nvCxnSpPr>
        <p:spPr>
          <a:xfrm flipV="1">
            <a:off x="2499498" y="2781307"/>
            <a:ext cx="0" cy="672133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0D60B235-A646-46A8-A4C2-1938D1207504}"/>
              </a:ext>
            </a:extLst>
          </p:cNvPr>
          <p:cNvSpPr txBox="1"/>
          <p:nvPr/>
        </p:nvSpPr>
        <p:spPr>
          <a:xfrm rot="16200000">
            <a:off x="2053345" y="2193384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SC-A</a:t>
            </a:r>
            <a:endParaRPr lang="en-CA" b="1" dirty="0"/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01A41E4E-639F-4D9B-A074-A2C8A1B2E00A}"/>
              </a:ext>
            </a:extLst>
          </p:cNvPr>
          <p:cNvCxnSpPr>
            <a:cxnSpLocks/>
          </p:cNvCxnSpPr>
          <p:nvPr/>
        </p:nvCxnSpPr>
        <p:spPr>
          <a:xfrm>
            <a:off x="2776841" y="3869639"/>
            <a:ext cx="76008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285145AC-DE18-4A7A-82FE-5676E0EDA15A}"/>
              </a:ext>
            </a:extLst>
          </p:cNvPr>
          <p:cNvSpPr txBox="1"/>
          <p:nvPr/>
        </p:nvSpPr>
        <p:spPr>
          <a:xfrm>
            <a:off x="3616345" y="3700361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SC-H</a:t>
            </a:r>
            <a:endParaRPr lang="en-CA" b="1" dirty="0"/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30F013D6-8125-411B-A3CB-FB79AD5E332D}"/>
              </a:ext>
            </a:extLst>
          </p:cNvPr>
          <p:cNvCxnSpPr>
            <a:cxnSpLocks/>
          </p:cNvCxnSpPr>
          <p:nvPr/>
        </p:nvCxnSpPr>
        <p:spPr>
          <a:xfrm>
            <a:off x="4931782" y="3875347"/>
            <a:ext cx="76008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418362B7-6497-4E25-9C8B-F61B7BC7F669}"/>
              </a:ext>
            </a:extLst>
          </p:cNvPr>
          <p:cNvSpPr txBox="1"/>
          <p:nvPr/>
        </p:nvSpPr>
        <p:spPr>
          <a:xfrm>
            <a:off x="5771286" y="3706069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SC-A</a:t>
            </a:r>
            <a:endParaRPr lang="en-CA" b="1" dirty="0"/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16B9A05A-ECD8-42B4-B912-20BE8FEAF376}"/>
              </a:ext>
            </a:extLst>
          </p:cNvPr>
          <p:cNvCxnSpPr>
            <a:cxnSpLocks/>
          </p:cNvCxnSpPr>
          <p:nvPr/>
        </p:nvCxnSpPr>
        <p:spPr>
          <a:xfrm>
            <a:off x="6858229" y="3872686"/>
            <a:ext cx="76008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8377270A-454C-4A2D-8107-4622FD65778B}"/>
              </a:ext>
            </a:extLst>
          </p:cNvPr>
          <p:cNvSpPr txBox="1"/>
          <p:nvPr/>
        </p:nvSpPr>
        <p:spPr>
          <a:xfrm>
            <a:off x="7697733" y="3703408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D3</a:t>
            </a:r>
            <a:endParaRPr lang="en-CA" b="1" dirty="0"/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E4995E96-8FF6-4EA1-AE42-B6FC61C4B21E}"/>
              </a:ext>
            </a:extLst>
          </p:cNvPr>
          <p:cNvCxnSpPr>
            <a:cxnSpLocks/>
          </p:cNvCxnSpPr>
          <p:nvPr/>
        </p:nvCxnSpPr>
        <p:spPr>
          <a:xfrm>
            <a:off x="9177010" y="3868095"/>
            <a:ext cx="76008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2FEB8712-C029-4400-9BC2-4F8F10724018}"/>
              </a:ext>
            </a:extLst>
          </p:cNvPr>
          <p:cNvSpPr txBox="1"/>
          <p:nvPr/>
        </p:nvSpPr>
        <p:spPr>
          <a:xfrm>
            <a:off x="10016514" y="3698817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D8</a:t>
            </a:r>
            <a:endParaRPr lang="en-CA" b="1" dirty="0"/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883DECEF-0CDB-48F9-A0FE-FD186BFB11D5}"/>
              </a:ext>
            </a:extLst>
          </p:cNvPr>
          <p:cNvCxnSpPr>
            <a:cxnSpLocks/>
          </p:cNvCxnSpPr>
          <p:nvPr/>
        </p:nvCxnSpPr>
        <p:spPr>
          <a:xfrm>
            <a:off x="9093373" y="5874572"/>
            <a:ext cx="76008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2BB40E2D-6ABC-438E-B21E-BDD538A44591}"/>
              </a:ext>
            </a:extLst>
          </p:cNvPr>
          <p:cNvSpPr txBox="1"/>
          <p:nvPr/>
        </p:nvSpPr>
        <p:spPr>
          <a:xfrm>
            <a:off x="9932877" y="5705294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D5</a:t>
            </a:r>
            <a:endParaRPr lang="en-CA" b="1" dirty="0"/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727F3CD3-2958-40B1-AAE2-611D150C811A}"/>
              </a:ext>
            </a:extLst>
          </p:cNvPr>
          <p:cNvCxnSpPr>
            <a:cxnSpLocks/>
          </p:cNvCxnSpPr>
          <p:nvPr/>
        </p:nvCxnSpPr>
        <p:spPr>
          <a:xfrm>
            <a:off x="9092023" y="1820085"/>
            <a:ext cx="76008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58FA44EF-CCC0-4CBE-9ACF-29DF2000D1B3}"/>
              </a:ext>
            </a:extLst>
          </p:cNvPr>
          <p:cNvSpPr txBox="1"/>
          <p:nvPr/>
        </p:nvSpPr>
        <p:spPr>
          <a:xfrm>
            <a:off x="9931527" y="1650807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D5</a:t>
            </a:r>
            <a:endParaRPr lang="en-CA" b="1" dirty="0"/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5D8B8316-93B8-4E97-9569-90B79263F8A4}"/>
              </a:ext>
            </a:extLst>
          </p:cNvPr>
          <p:cNvCxnSpPr>
            <a:cxnSpLocks/>
          </p:cNvCxnSpPr>
          <p:nvPr/>
        </p:nvCxnSpPr>
        <p:spPr>
          <a:xfrm flipV="1">
            <a:off x="321220" y="2780071"/>
            <a:ext cx="6657" cy="67336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06769769-9036-4B4F-B39E-5BA6CCC2D9C4}"/>
              </a:ext>
            </a:extLst>
          </p:cNvPr>
          <p:cNvSpPr txBox="1"/>
          <p:nvPr/>
        </p:nvSpPr>
        <p:spPr>
          <a:xfrm rot="16200000">
            <a:off x="-89791" y="2155189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SC-A</a:t>
            </a:r>
            <a:endParaRPr lang="en-CA" b="1" dirty="0"/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F1925994-A852-4B17-A8F3-DE8BF2B31CE4}"/>
              </a:ext>
            </a:extLst>
          </p:cNvPr>
          <p:cNvCxnSpPr>
            <a:cxnSpLocks/>
            <a:endCxn id="51" idx="1"/>
          </p:cNvCxnSpPr>
          <p:nvPr/>
        </p:nvCxnSpPr>
        <p:spPr>
          <a:xfrm flipH="1" flipV="1">
            <a:off x="4507813" y="3120265"/>
            <a:ext cx="6940" cy="313926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D873BF3-A168-495C-8921-89E685FF7ED3}"/>
              </a:ext>
            </a:extLst>
          </p:cNvPr>
          <p:cNvSpPr txBox="1"/>
          <p:nvPr/>
        </p:nvSpPr>
        <p:spPr>
          <a:xfrm rot="16200000">
            <a:off x="3818503" y="2261678"/>
            <a:ext cx="13786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Zombie  NIR</a:t>
            </a:r>
            <a:endParaRPr lang="en-CA" b="1" dirty="0"/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27E5F7BE-6DA5-4CFA-B49F-5A9C6F978F0E}"/>
              </a:ext>
            </a:extLst>
          </p:cNvPr>
          <p:cNvCxnSpPr>
            <a:cxnSpLocks/>
          </p:cNvCxnSpPr>
          <p:nvPr/>
        </p:nvCxnSpPr>
        <p:spPr>
          <a:xfrm flipV="1">
            <a:off x="6574786" y="2715159"/>
            <a:ext cx="0" cy="672133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E7C0AA85-9B30-466A-B060-05F4E74AB08B}"/>
              </a:ext>
            </a:extLst>
          </p:cNvPr>
          <p:cNvSpPr txBox="1"/>
          <p:nvPr/>
        </p:nvSpPr>
        <p:spPr>
          <a:xfrm rot="16200000">
            <a:off x="6128633" y="2127236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SC-H</a:t>
            </a:r>
            <a:endParaRPr lang="en-CA" b="1" dirty="0"/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A62603CC-E37B-49F4-90CC-EA8BA0E538F9}"/>
              </a:ext>
            </a:extLst>
          </p:cNvPr>
          <p:cNvCxnSpPr>
            <a:cxnSpLocks/>
          </p:cNvCxnSpPr>
          <p:nvPr/>
        </p:nvCxnSpPr>
        <p:spPr>
          <a:xfrm flipV="1">
            <a:off x="8781972" y="2770616"/>
            <a:ext cx="0" cy="672133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70BFEA53-588A-4188-9B67-1665E5A40FEC}"/>
              </a:ext>
            </a:extLst>
          </p:cNvPr>
          <p:cNvSpPr txBox="1"/>
          <p:nvPr/>
        </p:nvSpPr>
        <p:spPr>
          <a:xfrm rot="16200000">
            <a:off x="8335819" y="2182693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D4</a:t>
            </a:r>
            <a:endParaRPr lang="en-CA" b="1" dirty="0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B60FD3EF-099A-48A9-B702-1405CE289D7B}"/>
              </a:ext>
            </a:extLst>
          </p:cNvPr>
          <p:cNvSpPr/>
          <p:nvPr/>
        </p:nvSpPr>
        <p:spPr>
          <a:xfrm>
            <a:off x="7768572" y="2540516"/>
            <a:ext cx="577992" cy="3492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CD3 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</a:rPr>
              <a:t>22,5</a:t>
            </a:r>
            <a:endParaRPr lang="en-CA" sz="1000" dirty="0">
              <a:solidFill>
                <a:schemeClr val="tx1"/>
              </a:solidFill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7FAB327E-6084-4280-BAAB-80FBDE703057}"/>
              </a:ext>
            </a:extLst>
          </p:cNvPr>
          <p:cNvSpPr/>
          <p:nvPr/>
        </p:nvSpPr>
        <p:spPr>
          <a:xfrm>
            <a:off x="9984608" y="546142"/>
            <a:ext cx="548282" cy="2863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CD5</a:t>
            </a:r>
            <a:r>
              <a:rPr lang="en-US" sz="1000" baseline="30000" dirty="0">
                <a:solidFill>
                  <a:schemeClr val="tx1"/>
                </a:solidFill>
              </a:rPr>
              <a:t>high</a:t>
            </a:r>
            <a:r>
              <a:rPr lang="en-US" sz="1000" dirty="0">
                <a:solidFill>
                  <a:schemeClr val="tx1"/>
                </a:solidFill>
              </a:rPr>
              <a:t> 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</a:rPr>
              <a:t>30,8</a:t>
            </a:r>
            <a:endParaRPr lang="en-CA" sz="1000" dirty="0">
              <a:solidFill>
                <a:schemeClr val="tx1"/>
              </a:solidFill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E96574C8-44A0-47C9-B777-58162D7FF8A2}"/>
              </a:ext>
            </a:extLst>
          </p:cNvPr>
          <p:cNvSpPr/>
          <p:nvPr/>
        </p:nvSpPr>
        <p:spPr>
          <a:xfrm>
            <a:off x="9303826" y="546142"/>
            <a:ext cx="548282" cy="2863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CD5</a:t>
            </a:r>
            <a:r>
              <a:rPr lang="en-US" sz="1000" baseline="30000" dirty="0">
                <a:solidFill>
                  <a:schemeClr val="tx1"/>
                </a:solidFill>
              </a:rPr>
              <a:t>low</a:t>
            </a:r>
            <a:r>
              <a:rPr lang="en-US" sz="1000" dirty="0">
                <a:solidFill>
                  <a:schemeClr val="tx1"/>
                </a:solidFill>
              </a:rPr>
              <a:t> 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</a:rPr>
              <a:t>30,2</a:t>
            </a:r>
            <a:endParaRPr lang="en-CA" sz="1000" dirty="0">
              <a:solidFill>
                <a:schemeClr val="tx1"/>
              </a:solidFill>
            </a:endParaRP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13CF00D1-C0B3-4AD7-89AE-B82C8BA93D6E}"/>
              </a:ext>
            </a:extLst>
          </p:cNvPr>
          <p:cNvSpPr/>
          <p:nvPr/>
        </p:nvSpPr>
        <p:spPr>
          <a:xfrm>
            <a:off x="9931527" y="4581016"/>
            <a:ext cx="548282" cy="2863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CD5</a:t>
            </a:r>
            <a:r>
              <a:rPr lang="en-US" sz="1000" baseline="30000" dirty="0">
                <a:solidFill>
                  <a:schemeClr val="tx1"/>
                </a:solidFill>
              </a:rPr>
              <a:t>high</a:t>
            </a:r>
            <a:r>
              <a:rPr lang="en-US" sz="1000" dirty="0">
                <a:solidFill>
                  <a:schemeClr val="tx1"/>
                </a:solidFill>
              </a:rPr>
              <a:t> 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</a:rPr>
              <a:t>30,1</a:t>
            </a:r>
            <a:endParaRPr lang="en-CA" sz="1000" dirty="0">
              <a:solidFill>
                <a:schemeClr val="tx1"/>
              </a:solidFill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9B640584-D523-4C18-9423-069B3B551E05}"/>
              </a:ext>
            </a:extLst>
          </p:cNvPr>
          <p:cNvSpPr/>
          <p:nvPr/>
        </p:nvSpPr>
        <p:spPr>
          <a:xfrm>
            <a:off x="9250745" y="4581016"/>
            <a:ext cx="548282" cy="2863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CD5</a:t>
            </a:r>
            <a:r>
              <a:rPr lang="en-US" sz="1000" baseline="30000" dirty="0">
                <a:solidFill>
                  <a:schemeClr val="tx1"/>
                </a:solidFill>
              </a:rPr>
              <a:t>low</a:t>
            </a:r>
            <a:r>
              <a:rPr lang="en-US" sz="1000" dirty="0">
                <a:solidFill>
                  <a:schemeClr val="tx1"/>
                </a:solidFill>
              </a:rPr>
              <a:t> 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</a:rPr>
              <a:t>30</a:t>
            </a:r>
            <a:endParaRPr lang="en-CA" sz="1000" dirty="0">
              <a:solidFill>
                <a:schemeClr val="tx1"/>
              </a:solidFill>
            </a:endParaRP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B30E0451-012B-4245-B96F-30CF71748FDD}"/>
              </a:ext>
            </a:extLst>
          </p:cNvPr>
          <p:cNvCxnSpPr>
            <a:cxnSpLocks/>
          </p:cNvCxnSpPr>
          <p:nvPr/>
        </p:nvCxnSpPr>
        <p:spPr>
          <a:xfrm flipV="1">
            <a:off x="8756423" y="4769293"/>
            <a:ext cx="6657" cy="67336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420D6E14-9041-4348-B87E-C9CDC1B0E873}"/>
              </a:ext>
            </a:extLst>
          </p:cNvPr>
          <p:cNvSpPr txBox="1"/>
          <p:nvPr/>
        </p:nvSpPr>
        <p:spPr>
          <a:xfrm rot="16200000">
            <a:off x="8345412" y="4144411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SC-A</a:t>
            </a:r>
            <a:endParaRPr lang="en-CA" b="1" dirty="0"/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FE375FC1-CE09-4324-BCB6-35D86B741674}"/>
              </a:ext>
            </a:extLst>
          </p:cNvPr>
          <p:cNvCxnSpPr>
            <a:cxnSpLocks/>
          </p:cNvCxnSpPr>
          <p:nvPr/>
        </p:nvCxnSpPr>
        <p:spPr>
          <a:xfrm flipV="1">
            <a:off x="8742349" y="832482"/>
            <a:ext cx="6657" cy="67336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7C98DEBF-502B-40E2-84EA-EBEFED68BE15}"/>
              </a:ext>
            </a:extLst>
          </p:cNvPr>
          <p:cNvSpPr txBox="1"/>
          <p:nvPr/>
        </p:nvSpPr>
        <p:spPr>
          <a:xfrm rot="16200000">
            <a:off x="8331338" y="207600"/>
            <a:ext cx="7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SC-A</a:t>
            </a:r>
            <a:endParaRPr lang="en-CA" b="1" dirty="0"/>
          </a:p>
        </p:txBody>
      </p:sp>
    </p:spTree>
    <p:extLst>
      <p:ext uri="{BB962C8B-B14F-4D97-AF65-F5344CB8AC3E}">
        <p14:creationId xmlns:p14="http://schemas.microsoft.com/office/powerpoint/2010/main" val="16710168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71C97A98-9344-4165-AA2F-C9D2696643A0}"/>
              </a:ext>
            </a:extLst>
          </p:cNvPr>
          <p:cNvSpPr txBox="1"/>
          <p:nvPr/>
        </p:nvSpPr>
        <p:spPr>
          <a:xfrm>
            <a:off x="21327" y="860486"/>
            <a:ext cx="51179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ure 2</a:t>
            </a:r>
            <a:endParaRPr lang="en-CA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F133831-B6A1-4EAC-8305-3AD4F42B31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4425" y="338041"/>
            <a:ext cx="5883150" cy="66086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29388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B59F7068-443C-467D-A2BB-873A0800275A}"/>
              </a:ext>
            </a:extLst>
          </p:cNvPr>
          <p:cNvSpPr txBox="1"/>
          <p:nvPr/>
        </p:nvSpPr>
        <p:spPr>
          <a:xfrm>
            <a:off x="2752054" y="800723"/>
            <a:ext cx="4110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ure 3</a:t>
            </a:r>
            <a:endParaRPr lang="en-CA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Content Placeholder 20">
            <a:extLst>
              <a:ext uri="{FF2B5EF4-FFF2-40B4-BE49-F238E27FC236}">
                <a16:creationId xmlns:a16="http://schemas.microsoft.com/office/drawing/2014/main" id="{E578EFC9-119E-4850-A00D-AA79450F724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752054" y="2205866"/>
            <a:ext cx="6687892" cy="35908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72344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TextBox 114">
            <a:extLst>
              <a:ext uri="{FF2B5EF4-FFF2-40B4-BE49-F238E27FC236}">
                <a16:creationId xmlns:a16="http://schemas.microsoft.com/office/drawing/2014/main" id="{CD250FA3-328F-49DC-ADA3-4E14B90D570A}"/>
              </a:ext>
            </a:extLst>
          </p:cNvPr>
          <p:cNvSpPr txBox="1"/>
          <p:nvPr/>
        </p:nvSpPr>
        <p:spPr>
          <a:xfrm>
            <a:off x="2072641" y="266040"/>
            <a:ext cx="31191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ure 4</a:t>
            </a:r>
            <a:endParaRPr lang="en-CA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4181EE1-A5E1-4443-B33C-18DF935594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0316" y="1403428"/>
            <a:ext cx="9266404" cy="4967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9494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4</Words>
  <Application>Microsoft Office PowerPoint</Application>
  <PresentationFormat>Widescreen</PresentationFormat>
  <Paragraphs>32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Supplementary Figures </vt:lpstr>
      <vt:lpstr>Supplementary Figure 1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 </dc:title>
  <dc:creator>Faizah Alotaibi</dc:creator>
  <cp:lastModifiedBy>Faizah Alotaibi</cp:lastModifiedBy>
  <cp:revision>2</cp:revision>
  <dcterms:created xsi:type="dcterms:W3CDTF">2020-11-20T20:23:32Z</dcterms:created>
  <dcterms:modified xsi:type="dcterms:W3CDTF">2020-11-24T01:29:05Z</dcterms:modified>
</cp:coreProperties>
</file>